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>
      <p:cViewPr varScale="1">
        <p:scale>
          <a:sx n="63" d="100"/>
          <a:sy n="63" d="100"/>
        </p:scale>
        <p:origin x="138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27584" y="332656"/>
            <a:ext cx="1701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dditional File 1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05842" y="5601814"/>
            <a:ext cx="846622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1. The microbial composition of each individual is shown at phylum level. The individuals are sorted by the abundance of </a:t>
            </a:r>
            <a:r>
              <a:rPr lang="en-US" altLang="zh-CN" dirty="0" err="1"/>
              <a:t>Bacteroidetes</a:t>
            </a:r>
            <a:r>
              <a:rPr lang="en-US" altLang="zh-CN" dirty="0"/>
              <a:t>.</a:t>
            </a:r>
            <a:endParaRPr lang="zh-CN" altLang="zh-CN" dirty="0"/>
          </a:p>
          <a:p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93C02259-FA92-1149-A6A9-481229543D6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651" b="37400"/>
          <a:stretch/>
        </p:blipFill>
        <p:spPr>
          <a:xfrm>
            <a:off x="1187624" y="1772816"/>
            <a:ext cx="6929938" cy="3672408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xmlns="" id="{6E3F1EB7-4B6D-DD45-9E70-58F886622659}"/>
              </a:ext>
            </a:extLst>
          </p:cNvPr>
          <p:cNvSpPr/>
          <p:nvPr/>
        </p:nvSpPr>
        <p:spPr>
          <a:xfrm>
            <a:off x="827584" y="1311151"/>
            <a:ext cx="132517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/>
              <a:t>Figure S1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1494860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27584" y="332656"/>
            <a:ext cx="1701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dditional File 1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640" y="1988840"/>
            <a:ext cx="6300192" cy="277103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67544" y="4941168"/>
            <a:ext cx="84662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S2. Metabolic pathways associated with </a:t>
            </a:r>
            <a:r>
              <a:rPr lang="en-US" altLang="zh-CN" dirty="0" err="1"/>
              <a:t>equol</a:t>
            </a:r>
            <a:r>
              <a:rPr lang="en-US" altLang="zh-CN" dirty="0"/>
              <a:t> concentration in urine. “*” denotes P &lt; 0.05 and “#” denotes P &lt; 0.01.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818594" y="1438219"/>
            <a:ext cx="132517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/>
              <a:t>Figure S2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49401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0</TotalTime>
  <Words>59</Words>
  <Application>Microsoft Office PowerPoint</Application>
  <PresentationFormat>全屏显示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宋体</vt:lpstr>
      <vt:lpstr>Arial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w</dc:creator>
  <cp:lastModifiedBy>zw</cp:lastModifiedBy>
  <cp:revision>9</cp:revision>
  <dcterms:created xsi:type="dcterms:W3CDTF">2018-09-03T03:01:42Z</dcterms:created>
  <dcterms:modified xsi:type="dcterms:W3CDTF">2019-04-10T09:11:53Z</dcterms:modified>
</cp:coreProperties>
</file>